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CC9EF0-8C46-438B-827A-C0DE2B567694}" v="3" dt="2020-08-05T21:44:41.2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21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0CCC9EF0-8C46-438B-827A-C0DE2B567694}"/>
    <pc:docChg chg="undo custSel modSld">
      <pc:chgData name="Lois Hoyer" userId="8c378a1a5b622d94" providerId="LiveId" clId="{0CCC9EF0-8C46-438B-827A-C0DE2B567694}" dt="2020-08-11T15:16:27.209" v="922" actId="20577"/>
      <pc:docMkLst>
        <pc:docMk/>
      </pc:docMkLst>
      <pc:sldChg chg="addSp modSp mod">
        <pc:chgData name="Lois Hoyer" userId="8c378a1a5b622d94" providerId="LiveId" clId="{0CCC9EF0-8C46-438B-827A-C0DE2B567694}" dt="2020-08-11T15:16:27.209" v="922" actId="20577"/>
        <pc:sldMkLst>
          <pc:docMk/>
          <pc:sldMk cId="1378078787" sldId="256"/>
        </pc:sldMkLst>
        <pc:spChg chg="add mod">
          <ac:chgData name="Lois Hoyer" userId="8c378a1a5b622d94" providerId="LiveId" clId="{0CCC9EF0-8C46-438B-827A-C0DE2B567694}" dt="2020-08-11T15:16:27.209" v="922" actId="20577"/>
          <ac:spMkLst>
            <pc:docMk/>
            <pc:sldMk cId="1378078787" sldId="256"/>
            <ac:spMk id="2" creationId="{E730592B-DCF6-4556-AB78-07E4946F57AC}"/>
          </ac:spMkLst>
        </pc:spChg>
        <pc:grpChg chg="mod">
          <ac:chgData name="Lois Hoyer" userId="8c378a1a5b622d94" providerId="LiveId" clId="{0CCC9EF0-8C46-438B-827A-C0DE2B567694}" dt="2020-08-05T18:30:51.320" v="480" actId="164"/>
          <ac:grpSpMkLst>
            <pc:docMk/>
            <pc:sldMk cId="1378078787" sldId="256"/>
            <ac:grpSpMk id="3" creationId="{21FD0266-DEF0-4155-90B2-84B704CB9E9C}"/>
          </ac:grpSpMkLst>
        </pc:grpChg>
        <pc:grpChg chg="add mod">
          <ac:chgData name="Lois Hoyer" userId="8c378a1a5b622d94" providerId="LiveId" clId="{0CCC9EF0-8C46-438B-827A-C0DE2B567694}" dt="2020-08-05T18:31:16.834" v="506" actId="1037"/>
          <ac:grpSpMkLst>
            <pc:docMk/>
            <pc:sldMk cId="1378078787" sldId="256"/>
            <ac:grpSpMk id="4" creationId="{E515E5CB-E8EB-4B95-8ABC-FA8399DC0F8B}"/>
          </ac:grpSpMkLst>
        </pc:grpChg>
        <pc:grpChg chg="mod">
          <ac:chgData name="Lois Hoyer" userId="8c378a1a5b622d94" providerId="LiveId" clId="{0CCC9EF0-8C46-438B-827A-C0DE2B567694}" dt="2020-08-05T18:30:51.320" v="480" actId="164"/>
          <ac:grpSpMkLst>
            <pc:docMk/>
            <pc:sldMk cId="1378078787" sldId="256"/>
            <ac:grpSpMk id="84" creationId="{ED0B5723-3E93-4BA0-9CD2-B3DB364A4A3C}"/>
          </ac:grpSpMkLst>
        </pc:grpChg>
        <pc:grpChg chg="mod">
          <ac:chgData name="Lois Hoyer" userId="8c378a1a5b622d94" providerId="LiveId" clId="{0CCC9EF0-8C46-438B-827A-C0DE2B567694}" dt="2020-08-05T18:30:51.320" v="480" actId="164"/>
          <ac:grpSpMkLst>
            <pc:docMk/>
            <pc:sldMk cId="1378078787" sldId="256"/>
            <ac:grpSpMk id="86" creationId="{4DDF4E2C-57D9-4525-869F-131919FBC7F8}"/>
          </ac:grpSpMkLst>
        </pc:grpChg>
        <pc:grpChg chg="mod">
          <ac:chgData name="Lois Hoyer" userId="8c378a1a5b622d94" providerId="LiveId" clId="{0CCC9EF0-8C46-438B-827A-C0DE2B567694}" dt="2020-08-05T18:30:51.320" v="480" actId="164"/>
          <ac:grpSpMkLst>
            <pc:docMk/>
            <pc:sldMk cId="1378078787" sldId="256"/>
            <ac:grpSpMk id="87" creationId="{63D3B546-62FE-4A6C-AF56-299C3B888E45}"/>
          </ac:grpSpMkLst>
        </pc:grpChg>
        <pc:grpChg chg="mod">
          <ac:chgData name="Lois Hoyer" userId="8c378a1a5b622d94" providerId="LiveId" clId="{0CCC9EF0-8C46-438B-827A-C0DE2B567694}" dt="2020-08-05T18:30:51.320" v="480" actId="164"/>
          <ac:grpSpMkLst>
            <pc:docMk/>
            <pc:sldMk cId="1378078787" sldId="256"/>
            <ac:grpSpMk id="88" creationId="{3977195D-2505-4ED1-8277-C84A00F3036D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104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825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973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91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362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878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450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861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799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8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65042-ED6E-4D5B-9260-6984CF83C706}" type="datetimeFigureOut">
              <a:rPr lang="en-US" smtClean="0"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359BB-E2D5-46F6-93ED-22B964C7F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65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515E5CB-E8EB-4B95-8ABC-FA8399DC0F8B}"/>
              </a:ext>
            </a:extLst>
          </p:cNvPr>
          <p:cNvGrpSpPr/>
          <p:nvPr/>
        </p:nvGrpSpPr>
        <p:grpSpPr>
          <a:xfrm>
            <a:off x="547793" y="968357"/>
            <a:ext cx="5832086" cy="3900603"/>
            <a:chOff x="414999" y="585178"/>
            <a:chExt cx="5832086" cy="390060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21FD0266-DEF0-4155-90B2-84B704CB9E9C}"/>
                </a:ext>
              </a:extLst>
            </p:cNvPr>
            <p:cNvGrpSpPr/>
            <p:nvPr/>
          </p:nvGrpSpPr>
          <p:grpSpPr>
            <a:xfrm>
              <a:off x="5297552" y="3015573"/>
              <a:ext cx="380232" cy="245017"/>
              <a:chOff x="5259542" y="3015573"/>
              <a:chExt cx="380232" cy="245017"/>
            </a:xfrm>
          </p:grpSpPr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49DF1BB5-4E06-4596-8109-859A577FB362}"/>
                  </a:ext>
                </a:extLst>
              </p:cNvPr>
              <p:cNvCxnSpPr/>
              <p:nvPr/>
            </p:nvCxnSpPr>
            <p:spPr>
              <a:xfrm>
                <a:off x="5401385" y="3015573"/>
                <a:ext cx="9654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31B5608-CF22-40CC-B058-80191DB128E0}"/>
                  </a:ext>
                </a:extLst>
              </p:cNvPr>
              <p:cNvSpPr txBox="1"/>
              <p:nvPr/>
            </p:nvSpPr>
            <p:spPr>
              <a:xfrm>
                <a:off x="5259542" y="3045146"/>
                <a:ext cx="3802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 kb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3977195D-2505-4ED1-8277-C84A00F3036D}"/>
                </a:ext>
              </a:extLst>
            </p:cNvPr>
            <p:cNvGrpSpPr/>
            <p:nvPr/>
          </p:nvGrpSpPr>
          <p:grpSpPr>
            <a:xfrm>
              <a:off x="1135622" y="585178"/>
              <a:ext cx="4390841" cy="801937"/>
              <a:chOff x="624397" y="585178"/>
              <a:chExt cx="4390841" cy="801937"/>
            </a:xfrm>
          </p:grpSpPr>
          <p:sp>
            <p:nvSpPr>
              <p:cNvPr id="7" name="Arrow: Right 6">
                <a:extLst>
                  <a:ext uri="{FF2B5EF4-FFF2-40B4-BE49-F238E27FC236}">
                    <a16:creationId xmlns:a16="http://schemas.microsoft.com/office/drawing/2014/main" id="{6C42FB8D-6600-48D7-86EA-FBA1868B2328}"/>
                  </a:ext>
                </a:extLst>
              </p:cNvPr>
              <p:cNvSpPr/>
              <p:nvPr/>
            </p:nvSpPr>
            <p:spPr>
              <a:xfrm flipH="1">
                <a:off x="968566" y="1071891"/>
                <a:ext cx="279986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8" name="Arrow: Right 7">
                <a:extLst>
                  <a:ext uri="{FF2B5EF4-FFF2-40B4-BE49-F238E27FC236}">
                    <a16:creationId xmlns:a16="http://schemas.microsoft.com/office/drawing/2014/main" id="{6B4C17CE-2D7E-4B1E-B293-0F3C902C481A}"/>
                  </a:ext>
                </a:extLst>
              </p:cNvPr>
              <p:cNvSpPr/>
              <p:nvPr/>
            </p:nvSpPr>
            <p:spPr>
              <a:xfrm flipH="1">
                <a:off x="2191874" y="949640"/>
                <a:ext cx="154475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9" name="Arrow: Right 8">
                <a:extLst>
                  <a:ext uri="{FF2B5EF4-FFF2-40B4-BE49-F238E27FC236}">
                    <a16:creationId xmlns:a16="http://schemas.microsoft.com/office/drawing/2014/main" id="{38CBFE13-6500-40E1-A2A5-B64FCFB0F78E}"/>
                  </a:ext>
                </a:extLst>
              </p:cNvPr>
              <p:cNvSpPr/>
              <p:nvPr/>
            </p:nvSpPr>
            <p:spPr>
              <a:xfrm flipH="1">
                <a:off x="2355160" y="1071891"/>
                <a:ext cx="154475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10" name="Arrow: Right 9">
                <a:extLst>
                  <a:ext uri="{FF2B5EF4-FFF2-40B4-BE49-F238E27FC236}">
                    <a16:creationId xmlns:a16="http://schemas.microsoft.com/office/drawing/2014/main" id="{FE761D44-AD6D-404C-B106-C1F9FA1A3357}"/>
                  </a:ext>
                </a:extLst>
              </p:cNvPr>
              <p:cNvSpPr/>
              <p:nvPr/>
            </p:nvSpPr>
            <p:spPr>
              <a:xfrm flipH="1">
                <a:off x="1844305" y="1071891"/>
                <a:ext cx="405497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11" name="Arrow: Right 10">
                <a:extLst>
                  <a:ext uri="{FF2B5EF4-FFF2-40B4-BE49-F238E27FC236}">
                    <a16:creationId xmlns:a16="http://schemas.microsoft.com/office/drawing/2014/main" id="{188DE591-F21A-4FD7-8D64-95EFD4DF297C}"/>
                  </a:ext>
                </a:extLst>
              </p:cNvPr>
              <p:cNvSpPr/>
              <p:nvPr/>
            </p:nvSpPr>
            <p:spPr>
              <a:xfrm>
                <a:off x="3832328" y="1071891"/>
                <a:ext cx="164130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12" name="Arrow: Right 11">
                <a:extLst>
                  <a:ext uri="{FF2B5EF4-FFF2-40B4-BE49-F238E27FC236}">
                    <a16:creationId xmlns:a16="http://schemas.microsoft.com/office/drawing/2014/main" id="{BDC33B38-B7AC-4CF8-A028-346BE792B407}"/>
                  </a:ext>
                </a:extLst>
              </p:cNvPr>
              <p:cNvSpPr/>
              <p:nvPr/>
            </p:nvSpPr>
            <p:spPr>
              <a:xfrm>
                <a:off x="3976404" y="949640"/>
                <a:ext cx="656519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sp>
            <p:nvSpPr>
              <p:cNvPr id="13" name="Arrow: Right 12">
                <a:extLst>
                  <a:ext uri="{FF2B5EF4-FFF2-40B4-BE49-F238E27FC236}">
                    <a16:creationId xmlns:a16="http://schemas.microsoft.com/office/drawing/2014/main" id="{2A2FD081-66F2-40EF-BC79-7A6325054D98}"/>
                  </a:ext>
                </a:extLst>
              </p:cNvPr>
              <p:cNvSpPr/>
              <p:nvPr/>
            </p:nvSpPr>
            <p:spPr>
              <a:xfrm>
                <a:off x="4613613" y="1071891"/>
                <a:ext cx="38619" cy="116241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6750" dirty="0"/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7BF93E02-4B6C-418F-85DD-35DCD4B01B0F}"/>
                  </a:ext>
                </a:extLst>
              </p:cNvPr>
              <p:cNvCxnSpPr/>
              <p:nvPr/>
            </p:nvCxnSpPr>
            <p:spPr>
              <a:xfrm>
                <a:off x="1251958" y="1130011"/>
                <a:ext cx="58990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D76CEE33-25FF-46EF-A537-ACD8D033B48F}"/>
                  </a:ext>
                </a:extLst>
              </p:cNvPr>
              <p:cNvCxnSpPr/>
              <p:nvPr/>
            </p:nvCxnSpPr>
            <p:spPr>
              <a:xfrm>
                <a:off x="2509635" y="1130011"/>
                <a:ext cx="132269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A9497E33-7C07-42AC-A6ED-04D65C3CF7FC}"/>
                  </a:ext>
                </a:extLst>
              </p:cNvPr>
              <p:cNvCxnSpPr/>
              <p:nvPr/>
            </p:nvCxnSpPr>
            <p:spPr>
              <a:xfrm>
                <a:off x="722398" y="1130011"/>
                <a:ext cx="2452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D675C017-6149-4809-8A41-2AEE09A52B2F}"/>
                  </a:ext>
                </a:extLst>
              </p:cNvPr>
              <p:cNvCxnSpPr/>
              <p:nvPr/>
            </p:nvCxnSpPr>
            <p:spPr>
              <a:xfrm>
                <a:off x="4656449" y="1130011"/>
                <a:ext cx="2452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0E870D1F-7F81-4E98-BEC9-9588420B16F1}"/>
                  </a:ext>
                </a:extLst>
              </p:cNvPr>
              <p:cNvSpPr txBox="1"/>
              <p:nvPr/>
            </p:nvSpPr>
            <p:spPr>
              <a:xfrm>
                <a:off x="624397" y="585178"/>
                <a:ext cx="16065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ercontig3.5; 1,368,217 bp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04E633BB-BE6E-46F1-9BD8-4B4BB56E09FA}"/>
                  </a:ext>
                </a:extLst>
              </p:cNvPr>
              <p:cNvSpPr txBox="1"/>
              <p:nvPr/>
            </p:nvSpPr>
            <p:spPr>
              <a:xfrm>
                <a:off x="750673" y="1187060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86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16AFF42A-4DDF-483A-A6F8-F3B24931FACD}"/>
                  </a:ext>
                </a:extLst>
              </p:cNvPr>
              <p:cNvSpPr txBox="1"/>
              <p:nvPr/>
            </p:nvSpPr>
            <p:spPr>
              <a:xfrm>
                <a:off x="1625405" y="1187060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87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85EFCD5-03CA-4493-9ACD-F817C5D6385C}"/>
                  </a:ext>
                </a:extLst>
              </p:cNvPr>
              <p:cNvSpPr txBox="1"/>
              <p:nvPr/>
            </p:nvSpPr>
            <p:spPr>
              <a:xfrm>
                <a:off x="1935159" y="781581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88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E0836D46-0C18-4566-A24E-FE9534425759}"/>
                  </a:ext>
                </a:extLst>
              </p:cNvPr>
              <p:cNvSpPr txBox="1"/>
              <p:nvPr/>
            </p:nvSpPr>
            <p:spPr>
              <a:xfrm>
                <a:off x="2259242" y="1187060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91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409AE68-D54E-4492-8EF3-D66DC8FBC080}"/>
                  </a:ext>
                </a:extLst>
              </p:cNvPr>
              <p:cNvSpPr txBox="1"/>
              <p:nvPr/>
            </p:nvSpPr>
            <p:spPr>
              <a:xfrm>
                <a:off x="3534442" y="1187060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97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A0CC6406-159F-4463-BA1D-622E97664E23}"/>
                  </a:ext>
                </a:extLst>
              </p:cNvPr>
              <p:cNvSpPr txBox="1"/>
              <p:nvPr/>
            </p:nvSpPr>
            <p:spPr>
              <a:xfrm>
                <a:off x="3901802" y="781581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98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2B360927-54F4-4A7F-B01C-63E35D36F731}"/>
                  </a:ext>
                </a:extLst>
              </p:cNvPr>
              <p:cNvSpPr txBox="1"/>
              <p:nvPr/>
            </p:nvSpPr>
            <p:spPr>
              <a:xfrm>
                <a:off x="4279139" y="1187060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799</a:t>
                </a:r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ED0B5723-3E93-4BA0-9CD2-B3DB364A4A3C}"/>
                </a:ext>
              </a:extLst>
            </p:cNvPr>
            <p:cNvGrpSpPr/>
            <p:nvPr/>
          </p:nvGrpSpPr>
          <p:grpSpPr>
            <a:xfrm>
              <a:off x="1119304" y="1692567"/>
              <a:ext cx="4423477" cy="696020"/>
              <a:chOff x="686960" y="1901529"/>
              <a:chExt cx="4423477" cy="696020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17EAED9-E351-4692-9D1A-020ABAFE10C7}"/>
                  </a:ext>
                </a:extLst>
              </p:cNvPr>
              <p:cNvGrpSpPr/>
              <p:nvPr/>
            </p:nvGrpSpPr>
            <p:grpSpPr>
              <a:xfrm>
                <a:off x="792255" y="2244361"/>
                <a:ext cx="4318182" cy="116241"/>
                <a:chOff x="854926" y="2062523"/>
                <a:chExt cx="16101452" cy="182880"/>
              </a:xfrm>
            </p:grpSpPr>
            <p:sp>
              <p:nvSpPr>
                <p:cNvPr id="50" name="Arrow: Right 49">
                  <a:extLst>
                    <a:ext uri="{FF2B5EF4-FFF2-40B4-BE49-F238E27FC236}">
                      <a16:creationId xmlns:a16="http://schemas.microsoft.com/office/drawing/2014/main" id="{63249190-4F7C-41AF-892D-9757DA45583B}"/>
                    </a:ext>
                  </a:extLst>
                </p:cNvPr>
                <p:cNvSpPr/>
                <p:nvPr/>
              </p:nvSpPr>
              <p:spPr>
                <a:xfrm>
                  <a:off x="14299201" y="2062523"/>
                  <a:ext cx="1728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51" name="Arrow: Right 50">
                  <a:extLst>
                    <a:ext uri="{FF2B5EF4-FFF2-40B4-BE49-F238E27FC236}">
                      <a16:creationId xmlns:a16="http://schemas.microsoft.com/office/drawing/2014/main" id="{B7D8B6E2-8E9F-4661-B26D-303368FF04C7}"/>
                    </a:ext>
                  </a:extLst>
                </p:cNvPr>
                <p:cNvSpPr/>
                <p:nvPr/>
              </p:nvSpPr>
              <p:spPr>
                <a:xfrm flipH="1">
                  <a:off x="1784101" y="2062523"/>
                  <a:ext cx="756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52" name="Arrow: Right 51">
                  <a:extLst>
                    <a:ext uri="{FF2B5EF4-FFF2-40B4-BE49-F238E27FC236}">
                      <a16:creationId xmlns:a16="http://schemas.microsoft.com/office/drawing/2014/main" id="{2A161590-0775-4534-9EBC-AFC6A681EE72}"/>
                    </a:ext>
                  </a:extLst>
                </p:cNvPr>
                <p:cNvSpPr/>
                <p:nvPr/>
              </p:nvSpPr>
              <p:spPr>
                <a:xfrm flipH="1">
                  <a:off x="3325651" y="2062523"/>
                  <a:ext cx="684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76A6B682-1126-451D-B5F0-51FF8D4741F3}"/>
                    </a:ext>
                  </a:extLst>
                </p:cNvPr>
                <p:cNvCxnSpPr/>
                <p:nvPr/>
              </p:nvCxnSpPr>
              <p:spPr>
                <a:xfrm>
                  <a:off x="854926" y="2153963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17F80286-BB2F-4EFF-AE71-ECB28D07FFE7}"/>
                    </a:ext>
                  </a:extLst>
                </p:cNvPr>
                <p:cNvCxnSpPr/>
                <p:nvPr/>
              </p:nvCxnSpPr>
              <p:spPr>
                <a:xfrm>
                  <a:off x="16041978" y="2153963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0A069C2F-33D0-4052-9234-B2432B8CA8DD}"/>
                    </a:ext>
                  </a:extLst>
                </p:cNvPr>
                <p:cNvCxnSpPr/>
                <p:nvPr/>
              </p:nvCxnSpPr>
              <p:spPr>
                <a:xfrm>
                  <a:off x="4024426" y="2153963"/>
                  <a:ext cx="1026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D1CC1167-EB94-4E29-BD23-0DA7598E4E77}"/>
                    </a:ext>
                  </a:extLst>
                </p:cNvPr>
                <p:cNvCxnSpPr/>
                <p:nvPr/>
              </p:nvCxnSpPr>
              <p:spPr>
                <a:xfrm>
                  <a:off x="2554876" y="2153963"/>
                  <a:ext cx="75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6521632-4652-4610-94A4-A3401E0A374F}"/>
                  </a:ext>
                </a:extLst>
              </p:cNvPr>
              <p:cNvSpPr txBox="1"/>
              <p:nvPr/>
            </p:nvSpPr>
            <p:spPr>
              <a:xfrm>
                <a:off x="686960" y="1901529"/>
                <a:ext cx="16065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ercontig3.5; 1,368,217 bp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A8F7C8B8-CF5E-4BB0-A195-CCB787B7822C}"/>
                  </a:ext>
                </a:extLst>
              </p:cNvPr>
              <p:cNvSpPr txBox="1"/>
              <p:nvPr/>
            </p:nvSpPr>
            <p:spPr>
              <a:xfrm>
                <a:off x="686960" y="2397494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870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63EDFEFF-D537-4B70-8520-9306E2509AF1}"/>
                  </a:ext>
                </a:extLst>
              </p:cNvPr>
              <p:cNvSpPr txBox="1"/>
              <p:nvPr/>
            </p:nvSpPr>
            <p:spPr>
              <a:xfrm>
                <a:off x="1345863" y="2397494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871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94AA0880-913C-4C53-8D8D-313F176EABE5}"/>
                  </a:ext>
                </a:extLst>
              </p:cNvPr>
              <p:cNvSpPr txBox="1"/>
              <p:nvPr/>
            </p:nvSpPr>
            <p:spPr>
              <a:xfrm>
                <a:off x="4272263" y="2397494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3882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4DDF4E2C-57D9-4525-869F-131919FBC7F8}"/>
                </a:ext>
              </a:extLst>
            </p:cNvPr>
            <p:cNvGrpSpPr/>
            <p:nvPr/>
          </p:nvGrpSpPr>
          <p:grpSpPr>
            <a:xfrm>
              <a:off x="1909778" y="2694039"/>
              <a:ext cx="2842528" cy="712914"/>
              <a:chOff x="862875" y="2683420"/>
              <a:chExt cx="2842528" cy="712914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9F9E0D56-0707-4B0B-9927-C908CA1E453D}"/>
                  </a:ext>
                </a:extLst>
              </p:cNvPr>
              <p:cNvGrpSpPr/>
              <p:nvPr/>
            </p:nvGrpSpPr>
            <p:grpSpPr>
              <a:xfrm>
                <a:off x="967627" y="3046170"/>
                <a:ext cx="2728848" cy="116241"/>
                <a:chOff x="929146" y="4043369"/>
                <a:chExt cx="10175211" cy="182880"/>
              </a:xfrm>
            </p:grpSpPr>
            <p:sp>
              <p:nvSpPr>
                <p:cNvPr id="39" name="Arrow: Right 38">
                  <a:extLst>
                    <a:ext uri="{FF2B5EF4-FFF2-40B4-BE49-F238E27FC236}">
                      <a16:creationId xmlns:a16="http://schemas.microsoft.com/office/drawing/2014/main" id="{95E97B0A-FF89-47E1-B32F-C948666DFF93}"/>
                    </a:ext>
                  </a:extLst>
                </p:cNvPr>
                <p:cNvSpPr/>
                <p:nvPr/>
              </p:nvSpPr>
              <p:spPr>
                <a:xfrm flipH="1">
                  <a:off x="1859547" y="4043369"/>
                  <a:ext cx="468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40" name="Arrow: Right 39">
                  <a:extLst>
                    <a:ext uri="{FF2B5EF4-FFF2-40B4-BE49-F238E27FC236}">
                      <a16:creationId xmlns:a16="http://schemas.microsoft.com/office/drawing/2014/main" id="{198CD86D-2DDF-4E7B-A1DC-E5792266C1CF}"/>
                    </a:ext>
                  </a:extLst>
                </p:cNvPr>
                <p:cNvSpPr/>
                <p:nvPr/>
              </p:nvSpPr>
              <p:spPr>
                <a:xfrm flipH="1">
                  <a:off x="3295549" y="4043369"/>
                  <a:ext cx="432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41" name="Arrow: Right 40">
                  <a:extLst>
                    <a:ext uri="{FF2B5EF4-FFF2-40B4-BE49-F238E27FC236}">
                      <a16:creationId xmlns:a16="http://schemas.microsoft.com/office/drawing/2014/main" id="{BBD4BF82-A4D8-4D6E-B3CB-01EECAE19399}"/>
                    </a:ext>
                  </a:extLst>
                </p:cNvPr>
                <p:cNvSpPr/>
                <p:nvPr/>
              </p:nvSpPr>
              <p:spPr>
                <a:xfrm flipH="1">
                  <a:off x="5451551" y="4043369"/>
                  <a:ext cx="1944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42" name="Arrow: Right 41">
                  <a:extLst>
                    <a:ext uri="{FF2B5EF4-FFF2-40B4-BE49-F238E27FC236}">
                      <a16:creationId xmlns:a16="http://schemas.microsoft.com/office/drawing/2014/main" id="{0F586CFB-1B14-4B70-832E-7598A51E66AA}"/>
                    </a:ext>
                  </a:extLst>
                </p:cNvPr>
                <p:cNvSpPr/>
                <p:nvPr/>
              </p:nvSpPr>
              <p:spPr>
                <a:xfrm flipH="1">
                  <a:off x="8341953" y="4043369"/>
                  <a:ext cx="432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43" name="Arrow: Right 42">
                  <a:extLst>
                    <a:ext uri="{FF2B5EF4-FFF2-40B4-BE49-F238E27FC236}">
                      <a16:creationId xmlns:a16="http://schemas.microsoft.com/office/drawing/2014/main" id="{19E35173-B070-455A-A918-FEA95B0F2471}"/>
                    </a:ext>
                  </a:extLst>
                </p:cNvPr>
                <p:cNvSpPr/>
                <p:nvPr/>
              </p:nvSpPr>
              <p:spPr>
                <a:xfrm flipH="1">
                  <a:off x="9057955" y="4043369"/>
                  <a:ext cx="1116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id="{31FD302A-4BBA-4C00-8D62-3FC9BCC6C276}"/>
                    </a:ext>
                  </a:extLst>
                </p:cNvPr>
                <p:cNvCxnSpPr/>
                <p:nvPr/>
              </p:nvCxnSpPr>
              <p:spPr>
                <a:xfrm>
                  <a:off x="929146" y="4134809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221EEE0C-75B2-45EC-9AF3-EBC2D89BBC74}"/>
                    </a:ext>
                  </a:extLst>
                </p:cNvPr>
                <p:cNvCxnSpPr/>
                <p:nvPr/>
              </p:nvCxnSpPr>
              <p:spPr>
                <a:xfrm>
                  <a:off x="10189957" y="4134809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0B5289F2-11BA-4BAA-AB78-8459068F74F3}"/>
                    </a:ext>
                  </a:extLst>
                </p:cNvPr>
                <p:cNvCxnSpPr/>
                <p:nvPr/>
              </p:nvCxnSpPr>
              <p:spPr>
                <a:xfrm>
                  <a:off x="2343548" y="4134809"/>
                  <a:ext cx="9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D1B92CD7-A40B-41E2-B0BC-5D9DBF555C16}"/>
                    </a:ext>
                  </a:extLst>
                </p:cNvPr>
                <p:cNvCxnSpPr/>
                <p:nvPr/>
              </p:nvCxnSpPr>
              <p:spPr>
                <a:xfrm>
                  <a:off x="3743550" y="4134809"/>
                  <a:ext cx="169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8D4DF4EB-214F-44A4-A130-42BD2AB10A9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11552" y="4134809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1EB3934F-3C1F-41DD-AD23-265C68BCAEBA}"/>
                    </a:ext>
                  </a:extLst>
                </p:cNvPr>
                <p:cNvCxnSpPr/>
                <p:nvPr/>
              </p:nvCxnSpPr>
              <p:spPr>
                <a:xfrm>
                  <a:off x="8789954" y="4134809"/>
                  <a:ext cx="25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98EA37A6-7E91-4A1D-8B70-55F835F8B5A3}"/>
                  </a:ext>
                </a:extLst>
              </p:cNvPr>
              <p:cNvSpPr txBox="1"/>
              <p:nvPr/>
            </p:nvSpPr>
            <p:spPr>
              <a:xfrm>
                <a:off x="862875" y="2683420"/>
                <a:ext cx="16065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ercontig3.3; 2,216,334 bp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38529590-BB2E-43FC-9099-659AF030CC9A}"/>
                  </a:ext>
                </a:extLst>
              </p:cNvPr>
              <p:cNvSpPr txBox="1"/>
              <p:nvPr/>
            </p:nvSpPr>
            <p:spPr>
              <a:xfrm>
                <a:off x="862875" y="3196279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2227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2FF17005-8429-46F1-B9A1-2BAD7E84F8A9}"/>
                  </a:ext>
                </a:extLst>
              </p:cNvPr>
              <p:cNvSpPr txBox="1"/>
              <p:nvPr/>
            </p:nvSpPr>
            <p:spPr>
              <a:xfrm>
                <a:off x="1467276" y="3196279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2228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ACF46359-5489-468A-A1E2-A799F43B556F}"/>
                  </a:ext>
                </a:extLst>
              </p:cNvPr>
              <p:cNvSpPr txBox="1"/>
              <p:nvPr/>
            </p:nvSpPr>
            <p:spPr>
              <a:xfrm>
                <a:off x="2082147" y="3196279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2229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AD9FCB0-0969-4EEB-8324-12449696F78F}"/>
                  </a:ext>
                </a:extLst>
              </p:cNvPr>
              <p:cNvSpPr txBox="1"/>
              <p:nvPr/>
            </p:nvSpPr>
            <p:spPr>
              <a:xfrm>
                <a:off x="2645515" y="2849788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2292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DB5AF8EC-A35E-4880-9D6E-5B00AF033ED6}"/>
                  </a:ext>
                </a:extLst>
              </p:cNvPr>
              <p:cNvSpPr txBox="1"/>
              <p:nvPr/>
            </p:nvSpPr>
            <p:spPr>
              <a:xfrm>
                <a:off x="2969304" y="3196279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2293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63D3B546-62FE-4A6C-AF56-299C3B888E45}"/>
                </a:ext>
              </a:extLst>
            </p:cNvPr>
            <p:cNvGrpSpPr/>
            <p:nvPr/>
          </p:nvGrpSpPr>
          <p:grpSpPr>
            <a:xfrm>
              <a:off x="414999" y="3712405"/>
              <a:ext cx="5832086" cy="773376"/>
              <a:chOff x="545625" y="3712405"/>
              <a:chExt cx="5832086" cy="773376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83AAD324-118A-44DE-8189-FFD876445684}"/>
                  </a:ext>
                </a:extLst>
              </p:cNvPr>
              <p:cNvGrpSpPr/>
              <p:nvPr/>
            </p:nvGrpSpPr>
            <p:grpSpPr>
              <a:xfrm>
                <a:off x="658898" y="4132594"/>
                <a:ext cx="5718813" cy="116241"/>
                <a:chOff x="842226" y="5860589"/>
                <a:chExt cx="21324067" cy="182880"/>
              </a:xfrm>
            </p:grpSpPr>
            <p:sp>
              <p:nvSpPr>
                <p:cNvPr id="22" name="Arrow: Right 21">
                  <a:extLst>
                    <a:ext uri="{FF2B5EF4-FFF2-40B4-BE49-F238E27FC236}">
                      <a16:creationId xmlns:a16="http://schemas.microsoft.com/office/drawing/2014/main" id="{B028B51A-3B5C-41D7-AA8A-7BD15688711A}"/>
                    </a:ext>
                  </a:extLst>
                </p:cNvPr>
                <p:cNvSpPr/>
                <p:nvPr/>
              </p:nvSpPr>
              <p:spPr>
                <a:xfrm>
                  <a:off x="1765686" y="5860589"/>
                  <a:ext cx="3204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23" name="Arrow: Right 22">
                  <a:extLst>
                    <a:ext uri="{FF2B5EF4-FFF2-40B4-BE49-F238E27FC236}">
                      <a16:creationId xmlns:a16="http://schemas.microsoft.com/office/drawing/2014/main" id="{7BECA144-CD7B-407E-A949-B53EB7AC72AA}"/>
                    </a:ext>
                  </a:extLst>
                </p:cNvPr>
                <p:cNvSpPr/>
                <p:nvPr/>
              </p:nvSpPr>
              <p:spPr>
                <a:xfrm>
                  <a:off x="6158238" y="5860589"/>
                  <a:ext cx="792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/>
                </a:p>
              </p:txBody>
            </p:sp>
            <p:sp>
              <p:nvSpPr>
                <p:cNvPr id="24" name="Arrow: Right 23">
                  <a:extLst>
                    <a:ext uri="{FF2B5EF4-FFF2-40B4-BE49-F238E27FC236}">
                      <a16:creationId xmlns:a16="http://schemas.microsoft.com/office/drawing/2014/main" id="{226667AD-C016-4C88-B02F-E3D5C50F1F11}"/>
                    </a:ext>
                  </a:extLst>
                </p:cNvPr>
                <p:cNvSpPr/>
                <p:nvPr/>
              </p:nvSpPr>
              <p:spPr>
                <a:xfrm>
                  <a:off x="7058358" y="5860589"/>
                  <a:ext cx="252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/>
                </a:p>
              </p:txBody>
            </p:sp>
            <p:sp>
              <p:nvSpPr>
                <p:cNvPr id="25" name="Arrow: Right 24">
                  <a:extLst>
                    <a:ext uri="{FF2B5EF4-FFF2-40B4-BE49-F238E27FC236}">
                      <a16:creationId xmlns:a16="http://schemas.microsoft.com/office/drawing/2014/main" id="{FE9D1F66-718D-4E68-8DB5-9958467783F4}"/>
                    </a:ext>
                  </a:extLst>
                </p:cNvPr>
                <p:cNvSpPr/>
                <p:nvPr/>
              </p:nvSpPr>
              <p:spPr>
                <a:xfrm flipH="1">
                  <a:off x="19910838" y="5860589"/>
                  <a:ext cx="1332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/>
                </a:p>
              </p:txBody>
            </p:sp>
            <p:sp>
              <p:nvSpPr>
                <p:cNvPr id="26" name="Arrow: Right 25">
                  <a:extLst>
                    <a:ext uri="{FF2B5EF4-FFF2-40B4-BE49-F238E27FC236}">
                      <a16:creationId xmlns:a16="http://schemas.microsoft.com/office/drawing/2014/main" id="{1AC1A4D1-EA2D-431D-94FA-449456EC61E4}"/>
                    </a:ext>
                  </a:extLst>
                </p:cNvPr>
                <p:cNvSpPr/>
                <p:nvPr/>
              </p:nvSpPr>
              <p:spPr>
                <a:xfrm flipH="1">
                  <a:off x="16166598" y="5860589"/>
                  <a:ext cx="576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27" name="Arrow: Right 26">
                  <a:extLst>
                    <a:ext uri="{FF2B5EF4-FFF2-40B4-BE49-F238E27FC236}">
                      <a16:creationId xmlns:a16="http://schemas.microsoft.com/office/drawing/2014/main" id="{9AEACCA9-3917-4C4E-8C2A-D1117819701D}"/>
                    </a:ext>
                  </a:extLst>
                </p:cNvPr>
                <p:cNvSpPr/>
                <p:nvPr/>
              </p:nvSpPr>
              <p:spPr>
                <a:xfrm flipH="1">
                  <a:off x="18200718" y="5860589"/>
                  <a:ext cx="720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sp>
              <p:nvSpPr>
                <p:cNvPr id="28" name="Arrow: Right 27">
                  <a:extLst>
                    <a:ext uri="{FF2B5EF4-FFF2-40B4-BE49-F238E27FC236}">
                      <a16:creationId xmlns:a16="http://schemas.microsoft.com/office/drawing/2014/main" id="{C7438363-A7DB-4CA2-A95C-4941D22E1842}"/>
                    </a:ext>
                  </a:extLst>
                </p:cNvPr>
                <p:cNvSpPr/>
                <p:nvPr/>
              </p:nvSpPr>
              <p:spPr>
                <a:xfrm flipH="1">
                  <a:off x="7544478" y="5860589"/>
                  <a:ext cx="1476000" cy="182880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42900" tIns="171450" rIns="342900" bIns="17145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6750" dirty="0"/>
                </a:p>
              </p:txBody>
            </p: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3089FE3A-B820-4608-B242-6F03D10B6A64}"/>
                    </a:ext>
                  </a:extLst>
                </p:cNvPr>
                <p:cNvCxnSpPr/>
                <p:nvPr/>
              </p:nvCxnSpPr>
              <p:spPr>
                <a:xfrm>
                  <a:off x="842226" y="5952029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BC1DDAFF-12F3-4E17-BB91-458B4756BE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78746" y="5952029"/>
                  <a:ext cx="1170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F4A7359B-3054-45A9-A8FC-6FA2B085D8D7}"/>
                    </a:ext>
                  </a:extLst>
                </p:cNvPr>
                <p:cNvCxnSpPr/>
                <p:nvPr/>
              </p:nvCxnSpPr>
              <p:spPr>
                <a:xfrm>
                  <a:off x="9029538" y="5952029"/>
                  <a:ext cx="71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1FC77EFF-68AF-4D30-B85D-401A6F7E44DA}"/>
                    </a:ext>
                  </a:extLst>
                </p:cNvPr>
                <p:cNvCxnSpPr/>
                <p:nvPr/>
              </p:nvCxnSpPr>
              <p:spPr>
                <a:xfrm>
                  <a:off x="21251893" y="5952029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5252807C-3EAC-4600-805F-AC3581189070}"/>
                    </a:ext>
                  </a:extLst>
                </p:cNvPr>
                <p:cNvCxnSpPr/>
                <p:nvPr/>
              </p:nvCxnSpPr>
              <p:spPr>
                <a:xfrm>
                  <a:off x="18929778" y="5952029"/>
                  <a:ext cx="97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7612FFA8-13AF-4D8D-803B-7A008680A917}"/>
                    </a:ext>
                  </a:extLst>
                </p:cNvPr>
                <p:cNvCxnSpPr/>
                <p:nvPr/>
              </p:nvCxnSpPr>
              <p:spPr>
                <a:xfrm>
                  <a:off x="16751658" y="5952029"/>
                  <a:ext cx="144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79980A9F-B767-4DDA-ABBE-711DA0A3F8A3}"/>
                    </a:ext>
                  </a:extLst>
                </p:cNvPr>
                <p:cNvCxnSpPr/>
                <p:nvPr/>
              </p:nvCxnSpPr>
              <p:spPr>
                <a:xfrm>
                  <a:off x="6959298" y="5952029"/>
                  <a:ext cx="9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ABF9C94C-DDFA-4E20-95F2-92FF40E3681B}"/>
                    </a:ext>
                  </a:extLst>
                </p:cNvPr>
                <p:cNvCxnSpPr/>
                <p:nvPr/>
              </p:nvCxnSpPr>
              <p:spPr>
                <a:xfrm>
                  <a:off x="7319418" y="5952029"/>
                  <a:ext cx="21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0EC55EEE-2B55-4A08-AF57-0F4CF7122167}"/>
                  </a:ext>
                </a:extLst>
              </p:cNvPr>
              <p:cNvSpPr txBox="1"/>
              <p:nvPr/>
            </p:nvSpPr>
            <p:spPr>
              <a:xfrm>
                <a:off x="545625" y="3712405"/>
                <a:ext cx="16065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ercontig3.1; 2,474,448 bp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720F9ACC-B791-4EE9-B841-2E4BC56B9791}"/>
                  </a:ext>
                </a:extLst>
              </p:cNvPr>
              <p:cNvSpPr txBox="1"/>
              <p:nvPr/>
            </p:nvSpPr>
            <p:spPr>
              <a:xfrm>
                <a:off x="952061" y="4285726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0941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9EA3FD5F-3BDB-4CEB-B603-6F414E78D05C}"/>
                  </a:ext>
                </a:extLst>
              </p:cNvPr>
              <p:cNvSpPr txBox="1"/>
              <p:nvPr/>
            </p:nvSpPr>
            <p:spPr>
              <a:xfrm>
                <a:off x="1728125" y="4285726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28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0B46513D-0CCE-4EEF-A355-2B0A84C8AEDA}"/>
                  </a:ext>
                </a:extLst>
              </p:cNvPr>
              <p:cNvSpPr txBox="1"/>
              <p:nvPr/>
            </p:nvSpPr>
            <p:spPr>
              <a:xfrm>
                <a:off x="1994303" y="3919533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29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4D6E5BA1-E7F2-4BE2-8A78-8DDC6FF827B1}"/>
                  </a:ext>
                </a:extLst>
              </p:cNvPr>
              <p:cNvSpPr txBox="1"/>
              <p:nvPr/>
            </p:nvSpPr>
            <p:spPr>
              <a:xfrm>
                <a:off x="2381869" y="4285726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30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65D62B6-AF97-47D3-A250-6373E6A0C784}"/>
                  </a:ext>
                </a:extLst>
              </p:cNvPr>
              <p:cNvSpPr txBox="1"/>
              <p:nvPr/>
            </p:nvSpPr>
            <p:spPr>
              <a:xfrm>
                <a:off x="4449113" y="4285726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38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49F51F99-C515-4C55-A8D3-00E49E968AE3}"/>
                  </a:ext>
                </a:extLst>
              </p:cNvPr>
              <p:cNvSpPr txBox="1"/>
              <p:nvPr/>
            </p:nvSpPr>
            <p:spPr>
              <a:xfrm>
                <a:off x="5015238" y="3919533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39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129C93B8-7575-4390-BE47-D3476D8B1733}"/>
                  </a:ext>
                </a:extLst>
              </p:cNvPr>
              <p:cNvSpPr txBox="1"/>
              <p:nvPr/>
            </p:nvSpPr>
            <p:spPr>
              <a:xfrm>
                <a:off x="5596092" y="4285726"/>
                <a:ext cx="7360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G_01041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730592B-DCF6-4556-AB78-07E4946F57AC}"/>
              </a:ext>
            </a:extLst>
          </p:cNvPr>
          <p:cNvSpPr txBox="1"/>
          <p:nvPr/>
        </p:nvSpPr>
        <p:spPr>
          <a:xfrm>
            <a:off x="653115" y="5830823"/>
            <a:ext cx="562144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 |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i detected by BLAST i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tropicali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A-3404 genome assembly ASM633v3 drawn to scale, except for dashed lines which indicated extensive sequence length beyond the drawing scale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 were detected o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ercontig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1, 3.3, and 3.5. ORF designations assigned in this assembly were the basis for naming genes in subsequent revisions of the family composition: the ORF that contained the gene start was used as its final name.</a:t>
            </a:r>
          </a:p>
        </p:txBody>
      </p:sp>
    </p:spTree>
    <p:extLst>
      <p:ext uri="{BB962C8B-B14F-4D97-AF65-F5344CB8AC3E}">
        <p14:creationId xmlns:p14="http://schemas.microsoft.com/office/powerpoint/2010/main" val="1378078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</TotalTime>
  <Words>168</Words>
  <Application>Microsoft Office PowerPoint</Application>
  <PresentationFormat>Letter Paper (8.5x11 in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8</cp:revision>
  <dcterms:created xsi:type="dcterms:W3CDTF">2019-07-27T14:06:50Z</dcterms:created>
  <dcterms:modified xsi:type="dcterms:W3CDTF">2020-08-11T15:16:43Z</dcterms:modified>
</cp:coreProperties>
</file>